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56" r:id="rId2"/>
    <p:sldId id="388" r:id="rId3"/>
    <p:sldId id="258" r:id="rId4"/>
    <p:sldId id="257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93" d="100"/>
          <a:sy n="93" d="100"/>
        </p:scale>
        <p:origin x="92" y="25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BD8A790-9775-4C29-BFB9-4B01B53FF75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36896F74-9639-44DF-B324-642C99225DE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61CEB9A-1199-4348-8AC5-7C31546018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D4CF2-A3BE-4E20-B33B-A217EF98A95C}" type="datetimeFigureOut">
              <a:rPr lang="en-US" smtClean="0"/>
              <a:t>10/11/2020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C93923F-4398-4F65-BE2B-5C000C66DD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132A65F-2390-4F48-A3FB-E33A714FB7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CC037-DD18-4AF1-BAFF-F5ADF54E8D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98612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1AA602B-170D-4D23-89C2-85363BC0AA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327174D-BDD9-4F5E-B626-A49FFCE1778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8F89442-7E68-4233-B199-54138B5C24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D4CF2-A3BE-4E20-B33B-A217EF98A95C}" type="datetimeFigureOut">
              <a:rPr lang="en-US" smtClean="0"/>
              <a:t>10/11/2020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6AB0B1D-044D-4EF4-910F-BF5F987DB6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5898A34-F4D0-4495-82A5-9203E49237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CC037-DD18-4AF1-BAFF-F5ADF54E8D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019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05E91040-328E-4B94-8722-3C663FD43DE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D1A96BB-4149-42AC-9847-3C29A06BD1B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203F487-8BCE-43DE-9809-BCDDAF7069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D4CF2-A3BE-4E20-B33B-A217EF98A95C}" type="datetimeFigureOut">
              <a:rPr lang="en-US" smtClean="0"/>
              <a:t>10/11/2020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674266F-6DB5-4146-A965-6CF794B1CE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0290489-D3CC-4E31-8228-AA8AF7C85B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CC037-DD18-4AF1-BAFF-F5ADF54E8D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01425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06C9CCE-E711-4701-880D-F660DF71EC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E5ACD6F-EDE9-4069-A016-A7BC2F1D8B5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7A5C508-F8B8-49DE-BC4A-BCA083661F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D4CF2-A3BE-4E20-B33B-A217EF98A95C}" type="datetimeFigureOut">
              <a:rPr lang="en-US" smtClean="0"/>
              <a:t>10/11/2020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2D42DE3-ACAA-41EC-BECD-2FD49F5772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DEB4120-63F3-4B0E-8851-65EB76FB0F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CC037-DD18-4AF1-BAFF-F5ADF54E8D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2792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C9A5311-D2EC-4A69-AA7E-DFE099108E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17C34C6-D9B6-466C-8A28-7F1F90B33C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E35D5E7-179D-4F0A-9A25-8EF062377E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D4CF2-A3BE-4E20-B33B-A217EF98A95C}" type="datetimeFigureOut">
              <a:rPr lang="en-US" smtClean="0"/>
              <a:t>10/11/2020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9B5F7A3-4D21-4752-9065-864B04F8D9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BA5A8D5-519E-42A1-947B-701502964E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CC037-DD18-4AF1-BAFF-F5ADF54E8D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61456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4DB2C0F-E634-4533-8654-D5BC6BA644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B576628-BC87-46AA-ABF0-477A41C9918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AA4DD42-120A-4CA1-9424-B99A939F718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FD95E45-6110-49F4-92C2-9C4E1530DE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D4CF2-A3BE-4E20-B33B-A217EF98A95C}" type="datetimeFigureOut">
              <a:rPr lang="en-US" smtClean="0"/>
              <a:t>10/11/2020</a:t>
            </a:fld>
            <a:endParaRPr 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0BD1C2A-26A9-4951-A157-20C2889772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A4C701C-44F8-4843-884D-8CCFF807BA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CC037-DD18-4AF1-BAFF-F5ADF54E8D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64809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337F463-A917-4B31-9906-9C0EC3FF8A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E0A98E6-115B-4993-9105-C3BA543294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DACBC6B-0F21-41F9-8F27-5CCAE3CA686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40195B01-9CF0-461A-A13E-5F28F9CAECB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F9EF40EF-7F3B-4C4D-A03F-643E63B18EF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DF63E414-B524-4876-BDCD-70E4323C82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D4CF2-A3BE-4E20-B33B-A217EF98A95C}" type="datetimeFigureOut">
              <a:rPr lang="en-US" smtClean="0"/>
              <a:t>10/11/2020</a:t>
            </a:fld>
            <a:endParaRPr 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FDF4E38D-87E2-4ED3-97E7-FA8ED34309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801780C-8787-4394-9A83-22FFF6019F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CC037-DD18-4AF1-BAFF-F5ADF54E8D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72349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656EA3A-939A-4D22-8F6F-35FE6522F9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04007468-3FEF-403C-A331-8F74C3023E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D4CF2-A3BE-4E20-B33B-A217EF98A95C}" type="datetimeFigureOut">
              <a:rPr lang="en-US" smtClean="0"/>
              <a:t>10/11/2020</a:t>
            </a:fld>
            <a:endParaRPr 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D708FD4E-B986-4491-A396-C677815D14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31C1E164-29ED-411B-9F29-09B19569F6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CC037-DD18-4AF1-BAFF-F5ADF54E8D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81248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4DD8C210-0584-4DFC-8754-214ED4E55E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D4CF2-A3BE-4E20-B33B-A217EF98A95C}" type="datetimeFigureOut">
              <a:rPr lang="en-US" smtClean="0"/>
              <a:t>10/11/2020</a:t>
            </a:fld>
            <a:endParaRPr 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140DE393-9628-45A0-8E73-AE5DED8AB2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C1549C91-AE3E-4040-B48A-38EDE745E1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CC037-DD18-4AF1-BAFF-F5ADF54E8D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16049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AA13593-72F4-40CE-BE7F-77F4316F72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5CF73C6-D734-4980-AD10-F7460B5CCF8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13984DB-D067-4866-9AE7-CE03471D5BC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F15EFCC-5D64-4EE8-8513-F1EC1F566A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D4CF2-A3BE-4E20-B33B-A217EF98A95C}" type="datetimeFigureOut">
              <a:rPr lang="en-US" smtClean="0"/>
              <a:t>10/11/2020</a:t>
            </a:fld>
            <a:endParaRPr 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86B393B-19E6-40F9-9A97-C95AA24058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F05A9AC-5F7E-4904-A352-3B65B20D98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CC037-DD18-4AF1-BAFF-F5ADF54E8D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66500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EFE947D-A4F3-4FE5-8029-07EA152B75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D5DCFA21-13E1-4509-A204-6A431F28C24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BC31CB5-9FA0-4C91-942E-EF33ACC543E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C5B0188-4470-4B86-B7F1-42C414B0BF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D4CF2-A3BE-4E20-B33B-A217EF98A95C}" type="datetimeFigureOut">
              <a:rPr lang="en-US" smtClean="0"/>
              <a:t>10/11/2020</a:t>
            </a:fld>
            <a:endParaRPr 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181337B-42EE-4202-A280-0C2F8B0D74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60F6759-072F-42B1-902C-0B741C2883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CC037-DD18-4AF1-BAFF-F5ADF54E8D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47189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BD43CDCD-236D-4FEE-A9FE-6EDD00611C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F5E56D8-FED3-472B-91D3-A670056500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79AE9F9-B7B7-4637-B8CE-FBE7CF99481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7D4CF2-A3BE-4E20-B33B-A217EF98A95C}" type="datetimeFigureOut">
              <a:rPr lang="en-US" smtClean="0"/>
              <a:t>10/11/2020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8A0FF8A-1227-45FE-9FD2-ADFC204EB96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510FD8A-9EC3-4775-A762-1DDD98CF056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2CC037-DD18-4AF1-BAFF-F5ADF54E8D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56471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>
            <a:extLst>
              <a:ext uri="{FF2B5EF4-FFF2-40B4-BE49-F238E27FC236}">
                <a16:creationId xmlns:a16="http://schemas.microsoft.com/office/drawing/2014/main" id="{3303721B-C22D-4005-A0A1-EB880E157BE4}"/>
              </a:ext>
            </a:extLst>
          </p:cNvPr>
          <p:cNvSpPr txBox="1"/>
          <p:nvPr/>
        </p:nvSpPr>
        <p:spPr>
          <a:xfrm>
            <a:off x="3494508" y="5430931"/>
            <a:ext cx="66834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Clinical information of 499 patients in the TCGA-HNSC</a:t>
            </a:r>
          </a:p>
        </p:txBody>
      </p:sp>
      <p:graphicFrame>
        <p:nvGraphicFramePr>
          <p:cNvPr id="4" name="表格 2">
            <a:extLst>
              <a:ext uri="{FF2B5EF4-FFF2-40B4-BE49-F238E27FC236}">
                <a16:creationId xmlns:a16="http://schemas.microsoft.com/office/drawing/2014/main" id="{5FB8425B-3F02-41D4-A5C1-A0272EEC4CF3}"/>
              </a:ext>
            </a:extLst>
          </p:cNvPr>
          <p:cNvGraphicFramePr>
            <a:graphicFrameLocks noGrp="1"/>
          </p:cNvGraphicFramePr>
          <p:nvPr/>
        </p:nvGraphicFramePr>
        <p:xfrm>
          <a:off x="3494508" y="672377"/>
          <a:ext cx="4876029" cy="4544442"/>
        </p:xfrm>
        <a:graphic>
          <a:graphicData uri="http://schemas.openxmlformats.org/drawingml/2006/table">
            <a:tbl>
              <a:tblPr firstRow="1">
                <a:tableStyleId>{616DA210-FB5B-4158-B5E0-FEB733F419BA}</a:tableStyleId>
              </a:tblPr>
              <a:tblGrid>
                <a:gridCol w="952422">
                  <a:extLst>
                    <a:ext uri="{9D8B030D-6E8A-4147-A177-3AD203B41FA5}">
                      <a16:colId xmlns:a16="http://schemas.microsoft.com/office/drawing/2014/main" val="695594872"/>
                    </a:ext>
                  </a:extLst>
                </a:gridCol>
                <a:gridCol w="1002692">
                  <a:extLst>
                    <a:ext uri="{9D8B030D-6E8A-4147-A177-3AD203B41FA5}">
                      <a16:colId xmlns:a16="http://schemas.microsoft.com/office/drawing/2014/main" val="1487291639"/>
                    </a:ext>
                  </a:extLst>
                </a:gridCol>
                <a:gridCol w="969276">
                  <a:extLst>
                    <a:ext uri="{9D8B030D-6E8A-4147-A177-3AD203B41FA5}">
                      <a16:colId xmlns:a16="http://schemas.microsoft.com/office/drawing/2014/main" val="1719140896"/>
                    </a:ext>
                  </a:extLst>
                </a:gridCol>
                <a:gridCol w="931688">
                  <a:extLst>
                    <a:ext uri="{9D8B030D-6E8A-4147-A177-3AD203B41FA5}">
                      <a16:colId xmlns:a16="http://schemas.microsoft.com/office/drawing/2014/main" val="3052812582"/>
                    </a:ext>
                  </a:extLst>
                </a:gridCol>
                <a:gridCol w="1019951">
                  <a:extLst>
                    <a:ext uri="{9D8B030D-6E8A-4147-A177-3AD203B41FA5}">
                      <a16:colId xmlns:a16="http://schemas.microsoft.com/office/drawing/2014/main" val="3549347338"/>
                    </a:ext>
                  </a:extLst>
                </a:gridCol>
              </a:tblGrid>
              <a:tr h="324603">
                <a:tc gridSpan="5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515251679"/>
                  </a:ext>
                </a:extLst>
              </a:tr>
              <a:tr h="324603">
                <a:tc rowSpan="2">
                  <a:txBody>
                    <a:bodyPr/>
                    <a:lstStyle/>
                    <a:p>
                      <a:pPr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der</a:t>
                      </a:r>
                    </a:p>
                  </a:txBody>
                  <a:tcPr marL="45720" marR="45720" marT="0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e</a:t>
                      </a:r>
                    </a:p>
                  </a:txBody>
                  <a:tcPr marL="45720" marR="4572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6 (73.3%)</a:t>
                      </a:r>
                    </a:p>
                  </a:txBody>
                  <a:tcPr marL="45720" marR="4572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extLst>
                  <a:ext uri="{0D108BD9-81ED-4DB2-BD59-A6C34878D82A}">
                    <a16:rowId xmlns:a16="http://schemas.microsoft.com/office/drawing/2014/main" val="1566820886"/>
                  </a:ext>
                </a:extLst>
              </a:tr>
              <a:tr h="324603">
                <a:tc v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</a:p>
                  </a:txBody>
                  <a:tcPr marL="45720" marR="4572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3 (26.7%)</a:t>
                      </a:r>
                    </a:p>
                  </a:txBody>
                  <a:tcPr marL="45720" marR="4572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extLst>
                  <a:ext uri="{0D108BD9-81ED-4DB2-BD59-A6C34878D82A}">
                    <a16:rowId xmlns:a16="http://schemas.microsoft.com/office/drawing/2014/main" val="521807268"/>
                  </a:ext>
                </a:extLst>
              </a:tr>
              <a:tr h="324603">
                <a:tc rowSpan="3">
                  <a:txBody>
                    <a:bodyPr/>
                    <a:lstStyle/>
                    <a:p>
                      <a:pPr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umor stage</a:t>
                      </a:r>
                    </a:p>
                  </a:txBody>
                  <a:tcPr marL="45720" marR="45720" marT="0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age I &amp; II</a:t>
                      </a:r>
                    </a:p>
                  </a:txBody>
                  <a:tcPr marL="45720" marR="4572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 (19.4%)</a:t>
                      </a:r>
                    </a:p>
                  </a:txBody>
                  <a:tcPr marL="45720" marR="4572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extLst>
                  <a:ext uri="{0D108BD9-81ED-4DB2-BD59-A6C34878D82A}">
                    <a16:rowId xmlns:a16="http://schemas.microsoft.com/office/drawing/2014/main" val="2783100643"/>
                  </a:ext>
                </a:extLst>
              </a:tr>
              <a:tr h="324603">
                <a:tc v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age III &amp; IV</a:t>
                      </a:r>
                    </a:p>
                  </a:txBody>
                  <a:tcPr marL="45720" marR="4572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1 (68.3%)</a:t>
                      </a:r>
                    </a:p>
                  </a:txBody>
                  <a:tcPr marL="45720" marR="4572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extLst>
                  <a:ext uri="{0D108BD9-81ED-4DB2-BD59-A6C34878D82A}">
                    <a16:rowId xmlns:a16="http://schemas.microsoft.com/office/drawing/2014/main" val="684154961"/>
                  </a:ext>
                </a:extLst>
              </a:tr>
              <a:tr h="324603">
                <a:tc v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known</a:t>
                      </a:r>
                    </a:p>
                  </a:txBody>
                  <a:tcPr marL="45720" marR="4572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1 (12.3%)</a:t>
                      </a:r>
                    </a:p>
                  </a:txBody>
                  <a:tcPr marL="45720" marR="4572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extLst>
                  <a:ext uri="{0D108BD9-81ED-4DB2-BD59-A6C34878D82A}">
                    <a16:rowId xmlns:a16="http://schemas.microsoft.com/office/drawing/2014/main" val="2792978255"/>
                  </a:ext>
                </a:extLst>
              </a:tr>
              <a:tr h="324603">
                <a:tc rowSpan="3">
                  <a:txBody>
                    <a:bodyPr/>
                    <a:lstStyle/>
                    <a:p>
                      <a:pPr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diation Therapy</a:t>
                      </a:r>
                    </a:p>
                  </a:txBody>
                  <a:tcPr marL="45720" marR="45720" marT="0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</a:t>
                      </a:r>
                    </a:p>
                  </a:txBody>
                  <a:tcPr marL="45720" marR="4572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4 (54.9%)</a:t>
                      </a:r>
                    </a:p>
                  </a:txBody>
                  <a:tcPr marL="45720" marR="4572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extLst>
                  <a:ext uri="{0D108BD9-81ED-4DB2-BD59-A6C34878D82A}">
                    <a16:rowId xmlns:a16="http://schemas.microsoft.com/office/drawing/2014/main" val="8299720"/>
                  </a:ext>
                </a:extLst>
              </a:tr>
              <a:tr h="324603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</a:p>
                  </a:txBody>
                  <a:tcPr marL="45720" marR="4572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8 (29.7%)</a:t>
                      </a:r>
                    </a:p>
                  </a:txBody>
                  <a:tcPr marL="45720" marR="4572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extLst>
                  <a:ext uri="{0D108BD9-81ED-4DB2-BD59-A6C34878D82A}">
                    <a16:rowId xmlns:a16="http://schemas.microsoft.com/office/drawing/2014/main" val="1685148617"/>
                  </a:ext>
                </a:extLst>
              </a:tr>
              <a:tr h="324603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known</a:t>
                      </a:r>
                    </a:p>
                  </a:txBody>
                  <a:tcPr marL="45720" marR="4572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7 (15.4%)</a:t>
                      </a:r>
                    </a:p>
                  </a:txBody>
                  <a:tcPr marL="45720" marR="4572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extLst>
                  <a:ext uri="{0D108BD9-81ED-4DB2-BD59-A6C34878D82A}">
                    <a16:rowId xmlns:a16="http://schemas.microsoft.com/office/drawing/2014/main" val="3070555990"/>
                  </a:ext>
                </a:extLst>
              </a:tr>
              <a:tr h="324603">
                <a:tc gridSpan="2"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tiology</a:t>
                      </a:r>
                      <a:endParaRPr lang="en-US" sz="12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marT="0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2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PV+</a:t>
                      </a:r>
                    </a:p>
                  </a:txBody>
                  <a:tcPr marL="45720" marR="4572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PV-</a:t>
                      </a:r>
                    </a:p>
                  </a:txBody>
                  <a:tcPr marL="45720" marR="4572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known</a:t>
                      </a:r>
                    </a:p>
                  </a:txBody>
                  <a:tcPr marL="45720" marR="4572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11942471"/>
                  </a:ext>
                </a:extLst>
              </a:tr>
              <a:tr h="324603">
                <a:tc rowSpan="4">
                  <a:txBody>
                    <a:bodyPr/>
                    <a:lstStyle/>
                    <a:p>
                      <a:pPr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umor Location</a:t>
                      </a:r>
                    </a:p>
                  </a:txBody>
                  <a:tcPr marL="45720" marR="45720" marT="0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ypopharynx</a:t>
                      </a:r>
                      <a:endParaRPr lang="en-US" sz="1200" b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 (25.0%)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 (25.0%)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 (50.0%)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57004218"/>
                  </a:ext>
                </a:extLst>
              </a:tr>
              <a:tr h="324603">
                <a:tc v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al cavity</a:t>
                      </a:r>
                      <a:endParaRPr lang="en-US" sz="1200" b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 (7.3%)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5 (56.1%)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1 (36.6%)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62036230"/>
                  </a:ext>
                </a:extLst>
              </a:tr>
              <a:tr h="324603">
                <a:tc v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opharynx</a:t>
                      </a:r>
                      <a:endParaRPr lang="en-US" sz="1200" b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 (66.7%)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 (18.7%)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 (14.6%)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95881566"/>
                  </a:ext>
                </a:extLst>
              </a:tr>
              <a:tr h="324603">
                <a:tc v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rynx</a:t>
                      </a:r>
                      <a:endParaRPr lang="en-US" sz="1200" b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 (1.8%)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9 (69.9%)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 (28.3%)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4697743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818360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DD74BB23-938D-4EBF-933F-115BF96D1B26}"/>
              </a:ext>
            </a:extLst>
          </p:cNvPr>
          <p:cNvGraphicFramePr>
            <a:graphicFrameLocks noGrp="1"/>
          </p:cNvGraphicFramePr>
          <p:nvPr/>
        </p:nvGraphicFramePr>
        <p:xfrm>
          <a:off x="4169545" y="1588649"/>
          <a:ext cx="3852910" cy="2624120"/>
        </p:xfrm>
        <a:graphic>
          <a:graphicData uri="http://schemas.openxmlformats.org/drawingml/2006/table">
            <a:tbl>
              <a:tblPr firstRow="1" firstCol="1">
                <a:tableStyleId>{3B4B98B0-60AC-42C2-AFA5-B58CD77FA1E5}</a:tableStyleId>
              </a:tblPr>
              <a:tblGrid>
                <a:gridCol w="628489">
                  <a:extLst>
                    <a:ext uri="{9D8B030D-6E8A-4147-A177-3AD203B41FA5}">
                      <a16:colId xmlns:a16="http://schemas.microsoft.com/office/drawing/2014/main" val="2451933126"/>
                    </a:ext>
                  </a:extLst>
                </a:gridCol>
                <a:gridCol w="1311629">
                  <a:extLst>
                    <a:ext uri="{9D8B030D-6E8A-4147-A177-3AD203B41FA5}">
                      <a16:colId xmlns:a16="http://schemas.microsoft.com/office/drawing/2014/main" val="2701639580"/>
                    </a:ext>
                  </a:extLst>
                </a:gridCol>
                <a:gridCol w="1284303">
                  <a:extLst>
                    <a:ext uri="{9D8B030D-6E8A-4147-A177-3AD203B41FA5}">
                      <a16:colId xmlns:a16="http://schemas.microsoft.com/office/drawing/2014/main" val="986295931"/>
                    </a:ext>
                  </a:extLst>
                </a:gridCol>
                <a:gridCol w="628489">
                  <a:extLst>
                    <a:ext uri="{9D8B030D-6E8A-4147-A177-3AD203B41FA5}">
                      <a16:colId xmlns:a16="http://schemas.microsoft.com/office/drawing/2014/main" val="1989317694"/>
                    </a:ext>
                  </a:extLst>
                </a:gridCol>
              </a:tblGrid>
              <a:tr h="328015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3" marR="9053" marT="9053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LF2-v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3" marR="9053" marT="9053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LF2+v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3" marR="9053" marT="9053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3" marR="9053" marT="9053" marB="0" anchor="ctr"/>
                </a:tc>
                <a:extLst>
                  <a:ext uri="{0D108BD9-81ED-4DB2-BD59-A6C34878D82A}">
                    <a16:rowId xmlns:a16="http://schemas.microsoft.com/office/drawing/2014/main" val="961908746"/>
                  </a:ext>
                </a:extLst>
              </a:tr>
              <a:tr h="32801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T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3" marR="9053" marT="9053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5 ± 0.01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3" marR="9053" marT="9053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2 ± 0.01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3" marR="9053" marT="9053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</a:t>
                      </a:r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3" marR="9053" marT="9053" marB="0" anchor="ctr"/>
                </a:tc>
                <a:extLst>
                  <a:ext uri="{0D108BD9-81ED-4DB2-BD59-A6C34878D82A}">
                    <a16:rowId xmlns:a16="http://schemas.microsoft.com/office/drawing/2014/main" val="2652242123"/>
                  </a:ext>
                </a:extLst>
              </a:tr>
              <a:tr h="32801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T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3" marR="9053" marT="9053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5 ± 0.00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3" marR="9053" marT="9053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3 ± 0.00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3" marR="9053" marT="9053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7</a:t>
                      </a:r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3" marR="9053" marT="9053" marB="0" anchor="ctr"/>
                </a:tc>
                <a:extLst>
                  <a:ext uri="{0D108BD9-81ED-4DB2-BD59-A6C34878D82A}">
                    <a16:rowId xmlns:a16="http://schemas.microsoft.com/office/drawing/2014/main" val="2465618706"/>
                  </a:ext>
                </a:extLst>
              </a:tr>
              <a:tr h="32801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DST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3" marR="9053" marT="9053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9 ± 0.02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3" marR="9053" marT="9053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30 ± 0.02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3" marR="9053" marT="9053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2</a:t>
                      </a:r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3" marR="9053" marT="9053" marB="0" anchor="ctr"/>
                </a:tc>
                <a:extLst>
                  <a:ext uri="{0D108BD9-81ED-4DB2-BD59-A6C34878D82A}">
                    <a16:rowId xmlns:a16="http://schemas.microsoft.com/office/drawing/2014/main" val="4121752507"/>
                  </a:ext>
                </a:extLst>
              </a:tr>
              <a:tr h="32801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6ST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3" marR="9053" marT="9053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7 ± 0.01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3" marR="9053" marT="9053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8 ± 0.02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3" marR="9053" marT="9053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</a:t>
                      </a:r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9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3" marR="9053" marT="9053" marB="0" anchor="ctr"/>
                </a:tc>
                <a:extLst>
                  <a:ext uri="{0D108BD9-81ED-4DB2-BD59-A6C34878D82A}">
                    <a16:rowId xmlns:a16="http://schemas.microsoft.com/office/drawing/2014/main" val="1879566865"/>
                  </a:ext>
                </a:extLst>
              </a:tr>
              <a:tr h="32801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6ST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3" marR="9053" marT="9053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6 ± 0.00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3" marR="9053" marT="9053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0 ± 0.00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3" marR="9053" marT="9053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</a:t>
                      </a:r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3" marR="9053" marT="9053" marB="0" anchor="ctr"/>
                </a:tc>
                <a:extLst>
                  <a:ext uri="{0D108BD9-81ED-4DB2-BD59-A6C34878D82A}">
                    <a16:rowId xmlns:a16="http://schemas.microsoft.com/office/drawing/2014/main" val="3578258460"/>
                  </a:ext>
                </a:extLst>
              </a:tr>
              <a:tr h="32801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LF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3" marR="9053" marT="9053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8 ± 0.01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3" marR="9053" marT="9053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09 ± 0.02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3" marR="9053" marT="9053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0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3" marR="9053" marT="9053" marB="0" anchor="ctr"/>
                </a:tc>
                <a:extLst>
                  <a:ext uri="{0D108BD9-81ED-4DB2-BD59-A6C34878D82A}">
                    <a16:rowId xmlns:a16="http://schemas.microsoft.com/office/drawing/2014/main" val="291463334"/>
                  </a:ext>
                </a:extLst>
              </a:tr>
              <a:tr h="32801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LF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3" marR="9053" marT="9053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3 ± 0.00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3" marR="9053" marT="9053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8 ± 0.01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3" marR="9053" marT="9053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3" marR="9053" marT="9053" marB="0" anchor="ctr"/>
                </a:tc>
                <a:extLst>
                  <a:ext uri="{0D108BD9-81ED-4DB2-BD59-A6C34878D82A}">
                    <a16:rowId xmlns:a16="http://schemas.microsoft.com/office/drawing/2014/main" val="411409917"/>
                  </a:ext>
                </a:extLst>
              </a:tr>
            </a:tbl>
          </a:graphicData>
        </a:graphic>
      </p:graphicFrame>
      <p:sp>
        <p:nvSpPr>
          <p:cNvPr id="5" name="TextBox 5">
            <a:extLst>
              <a:ext uri="{FF2B5EF4-FFF2-40B4-BE49-F238E27FC236}">
                <a16:creationId xmlns:a16="http://schemas.microsoft.com/office/drawing/2014/main" id="{DB970BFD-08CC-41AD-8DBF-18E5CCB714CF}"/>
              </a:ext>
            </a:extLst>
          </p:cNvPr>
          <p:cNvSpPr txBox="1"/>
          <p:nvPr/>
        </p:nvSpPr>
        <p:spPr>
          <a:xfrm>
            <a:off x="3891263" y="4507626"/>
            <a:ext cx="452992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Table 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Relative expression of genes involved in the formation of 6-O-sulfate of HSPG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tween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LF2+ve (n=10) and SULF2-ve (n=11) tumors.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302487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1">
            <a:extLst>
              <a:ext uri="{FF2B5EF4-FFF2-40B4-BE49-F238E27FC236}">
                <a16:creationId xmlns:a16="http://schemas.microsoft.com/office/drawing/2014/main" id="{2B893ED2-9CAF-438C-824C-39E6643F6955}"/>
              </a:ext>
            </a:extLst>
          </p:cNvPr>
          <p:cNvSpPr txBox="1"/>
          <p:nvPr/>
        </p:nvSpPr>
        <p:spPr>
          <a:xfrm>
            <a:off x="766401" y="4353052"/>
            <a:ext cx="96279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(A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LF1 and SULF2 mRNA in tumor tissues of 499 patients in the TCGA-HNSC are weakly correlated (r=0.390, p&lt;0.001, Pearson Correlation)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LF1 and SULF2 mRNA in HNSCC tumor tissues does not differ between the early (stage I and II, n=94) and late (stage III and IV, n=337) stage tumors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LF2 mRNA in tumor tissues of different locations of the 499 patients (one-way ANOVA with Bonferroni correction, p=0.006 between larynx and oral cavity, p&lt;0.001 between oropharynx and oral cavity).</a:t>
            </a:r>
            <a:endParaRPr 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内容占位符 6" descr="图示, 示意图&#10;&#10;描述已自动生成">
            <a:extLst>
              <a:ext uri="{FF2B5EF4-FFF2-40B4-BE49-F238E27FC236}">
                <a16:creationId xmlns:a16="http://schemas.microsoft.com/office/drawing/2014/main" id="{A49613BF-E0B0-4619-A2FD-D828EB3B7DD8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7662" y="463930"/>
            <a:ext cx="8336280" cy="3519678"/>
          </a:xfrm>
        </p:spPr>
      </p:pic>
    </p:spTree>
    <p:extLst>
      <p:ext uri="{BB962C8B-B14F-4D97-AF65-F5344CB8AC3E}">
        <p14:creationId xmlns:p14="http://schemas.microsoft.com/office/powerpoint/2010/main" val="28892411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6">
            <a:extLst>
              <a:ext uri="{FF2B5EF4-FFF2-40B4-BE49-F238E27FC236}">
                <a16:creationId xmlns:a16="http://schemas.microsoft.com/office/drawing/2014/main" id="{868BDB74-F1A3-4952-BDA6-4ED465CF3A12}"/>
              </a:ext>
            </a:extLst>
          </p:cNvPr>
          <p:cNvSpPr txBox="1"/>
          <p:nvPr/>
        </p:nvSpPr>
        <p:spPr>
          <a:xfrm>
            <a:off x="8061650" y="222404"/>
            <a:ext cx="4010610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LF2 expression in tumor is associated with overall survival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S.tim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f HNSCC patients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 SULF1 mRNA in tumor tissues is associated with poor overall survival in 499 patients (HR=1.526, p=0.009);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igh SULF2 mRNA in tumor tissues is associated with poor overall survival in 499 patients (HR=1.482, p=0.008);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sitive IHC staining of SULF2 protein in tumor tissues has a poor survival trend (HR=1.617, p=0.207); a multivariate OS model evaluating the impact of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LF mRNA expression in 499 patients from the TCGA-HNSCC and 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)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LF2 protein in 124 patients from GUMC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 descr="图片包含 表格&#10;&#10;描述已自动生成">
            <a:extLst>
              <a:ext uri="{FF2B5EF4-FFF2-40B4-BE49-F238E27FC236}">
                <a16:creationId xmlns:a16="http://schemas.microsoft.com/office/drawing/2014/main" id="{AA774872-4217-48DD-94C4-1FD13088AA2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863" b="20183"/>
          <a:stretch/>
        </p:blipFill>
        <p:spPr>
          <a:xfrm>
            <a:off x="1295181" y="222404"/>
            <a:ext cx="6400800" cy="46012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55150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63</TotalTime>
  <Words>468</Words>
  <Application>Microsoft Office PowerPoint</Application>
  <PresentationFormat>宽屏</PresentationFormat>
  <Paragraphs>75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ang Yang</dc:creator>
  <cp:lastModifiedBy>Yang Yang</cp:lastModifiedBy>
  <cp:revision>10</cp:revision>
  <dcterms:created xsi:type="dcterms:W3CDTF">2020-07-11T10:47:07Z</dcterms:created>
  <dcterms:modified xsi:type="dcterms:W3CDTF">2020-10-11T21:44:09Z</dcterms:modified>
</cp:coreProperties>
</file>